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sldIdLst>
    <p:sldId id="263" r:id="rId2"/>
  </p:sldIdLst>
  <p:sldSz cx="6858000" cy="9144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>
        <p:scale>
          <a:sx n="140" d="100"/>
          <a:sy n="140" d="100"/>
        </p:scale>
        <p:origin x="830" y="-1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3810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7022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5657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1038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5272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8814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6678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6813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1196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9249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8449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A76B9-5569-44BF-BEEE-461BC397B502}" type="datetimeFigureOut">
              <a:rPr lang="ko-KR" altLang="en-US" smtClean="0"/>
              <a:t>2020-07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49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직사각형 10"/>
          <p:cNvSpPr/>
          <p:nvPr/>
        </p:nvSpPr>
        <p:spPr>
          <a:xfrm>
            <a:off x="135467" y="7753570"/>
            <a:ext cx="650915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Supplement Fig 1. Histopathological structure in the 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heart and kidney of 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Non-</a:t>
            </a:r>
            <a:r>
              <a:rPr lang="en-US" altLang="ko-KR" sz="1400" dirty="0" err="1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Tg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 and </a:t>
            </a:r>
            <a:r>
              <a:rPr lang="en-US" altLang="ko-KR" sz="1400" dirty="0" err="1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dTg</a:t>
            </a:r>
            <a:r>
              <a:rPr lang="en-US" altLang="ko-KR" sz="1400" dirty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. After harvesting the 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heart and kidney </a:t>
            </a:r>
            <a:r>
              <a:rPr lang="en-US" altLang="ko-KR" sz="1400" dirty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from 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subset groups, </a:t>
            </a:r>
            <a:r>
              <a:rPr lang="en-US" altLang="ko-KR" sz="1400" dirty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the histopathological changes in slide sections of 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these tissues were </a:t>
            </a:r>
            <a:r>
              <a:rPr lang="en-US" altLang="ko-KR" sz="1400" dirty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identified by staining with hematoxylin and eosin and observation at 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200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 and 400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en-US" altLang="ko-KR" sz="1400" dirty="0" smtClean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magnification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5208" y="4392381"/>
            <a:ext cx="2022288" cy="1513026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2721" y="4392381"/>
            <a:ext cx="2031642" cy="1513026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2034" y="1329190"/>
            <a:ext cx="2025463" cy="151909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2721" y="1329190"/>
            <a:ext cx="2031642" cy="151620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18480" y="1719407"/>
            <a:ext cx="856325" cy="5262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</a:t>
            </a:r>
            <a:r>
              <a:rPr lang="en-US" altLang="ko-KR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endParaRPr lang="en-US" altLang="ko-KR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rt</a:t>
            </a:r>
          </a:p>
          <a:p>
            <a:pPr algn="ctr"/>
            <a:endParaRPr lang="en-US" altLang="ko-K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ko-KR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ko-KR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ko-KR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Tg</a:t>
            </a:r>
            <a:endParaRPr lang="en-US" altLang="ko-KR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rt</a:t>
            </a:r>
          </a:p>
          <a:p>
            <a:pPr algn="ctr"/>
            <a:endParaRPr lang="en-US" altLang="ko-KR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ko-K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ko-KR" sz="2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ko-K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</a:t>
            </a:r>
            <a:r>
              <a:rPr lang="en-US" altLang="ko-KR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endParaRPr lang="en-US" altLang="ko-K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ideny</a:t>
            </a:r>
            <a:endParaRPr lang="en-US" altLang="ko-KR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ko-K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ko-KR" sz="2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ko-K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Tg</a:t>
            </a:r>
            <a:endParaRPr lang="en-US" altLang="ko-KR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121697" y="1003866"/>
            <a:ext cx="2688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400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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2720" y="2861722"/>
            <a:ext cx="2031642" cy="1513026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2033" y="2861722"/>
            <a:ext cx="2025463" cy="1513026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2720" y="5924913"/>
            <a:ext cx="2031642" cy="1514328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8383" y="5925361"/>
            <a:ext cx="2019113" cy="1513026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231547" y="343433"/>
            <a:ext cx="2133918" cy="400110"/>
          </a:xfrm>
          <a:prstGeom prst="rect">
            <a:avLst/>
          </a:prstGeom>
          <a:ln w="19050"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ko-KR" sz="2000" dirty="0">
                <a:latin typeface="Times New Roman" panose="02020603050405020304" pitchFamily="18" charset="0"/>
                <a:ea typeface="HY헤드라인M" panose="02030600000101010101" pitchFamily="18" charset="-127"/>
                <a:cs typeface="Times New Roman" panose="02020603050405020304" pitchFamily="18" charset="0"/>
              </a:rPr>
              <a:t>Supplement Fig 1. </a:t>
            </a:r>
            <a:endParaRPr lang="ko-KR" altLang="en-US" sz="2000" dirty="0"/>
          </a:p>
        </p:txBody>
      </p:sp>
    </p:spTree>
    <p:extLst>
      <p:ext uri="{BB962C8B-B14F-4D97-AF65-F5344CB8AC3E}">
        <p14:creationId xmlns:p14="http://schemas.microsoft.com/office/powerpoint/2010/main" val="1706686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82</TotalTime>
  <Words>69</Words>
  <Application>Microsoft Office PowerPoint</Application>
  <PresentationFormat>화면 슬라이드 쇼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HY헤드라인M</vt:lpstr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istrator</dc:creator>
  <cp:lastModifiedBy>user</cp:lastModifiedBy>
  <cp:revision>43</cp:revision>
  <cp:lastPrinted>2020-03-18T04:23:20Z</cp:lastPrinted>
  <dcterms:created xsi:type="dcterms:W3CDTF">2020-03-17T10:26:59Z</dcterms:created>
  <dcterms:modified xsi:type="dcterms:W3CDTF">2020-07-19T03:44:45Z</dcterms:modified>
</cp:coreProperties>
</file>